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04" r:id="rId1"/>
  </p:sldMasterIdLst>
  <p:notesMasterIdLst>
    <p:notesMasterId r:id="rId3"/>
  </p:notesMasterIdLst>
  <p:sldIdLst>
    <p:sldId id="256" r:id="rId2"/>
  </p:sldIdLst>
  <p:sldSz cx="18611850" cy="111601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BBC4"/>
    <a:srgbClr val="FFA59F"/>
    <a:srgbClr val="D50004"/>
    <a:srgbClr val="FF5047"/>
    <a:srgbClr val="FAF8FF"/>
    <a:srgbClr val="CC665B"/>
    <a:srgbClr val="F64E41"/>
    <a:srgbClr val="000000"/>
    <a:srgbClr val="FF7173"/>
    <a:srgbClr val="FFF8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054" autoAdjust="0"/>
    <p:restoredTop sz="96224"/>
  </p:normalViewPr>
  <p:slideViewPr>
    <p:cSldViewPr snapToGrid="0" snapToObjects="1">
      <p:cViewPr varScale="1">
        <p:scale>
          <a:sx n="85" d="100"/>
          <a:sy n="85" d="100"/>
        </p:scale>
        <p:origin x="16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E3330F-42F6-8C40-801D-FEEC3E5BD216}" type="datetimeFigureOut">
              <a:rPr lang="el-GR" smtClean="0"/>
              <a:t>5/8/20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855663" y="1143000"/>
            <a:ext cx="5146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2C8061-3BDF-9C41-B9C9-4997D44908E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21466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1pPr>
    <a:lvl2pPr marL="453908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2pPr>
    <a:lvl3pPr marL="907816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3pPr>
    <a:lvl4pPr marL="1361724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4pPr>
    <a:lvl5pPr marL="1815633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5pPr>
    <a:lvl6pPr marL="2269541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6pPr>
    <a:lvl7pPr marL="2723449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7pPr>
    <a:lvl8pPr marL="3177357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8pPr>
    <a:lvl9pPr marL="3631265" algn="l" defTabSz="907816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>
          <a:xfrm>
            <a:off x="855663" y="1143000"/>
            <a:ext cx="5146675" cy="3086100"/>
          </a:xfrm>
        </p:spPr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2C8061-3BDF-9C41-B9C9-4997D44908EA}" type="slidenum">
              <a:rPr lang="el-GR" smtClean="0"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69426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26481" y="1826438"/>
            <a:ext cx="13958888" cy="3885377"/>
          </a:xfrm>
        </p:spPr>
        <p:txBody>
          <a:bodyPr anchor="b"/>
          <a:lstStyle>
            <a:lvl1pPr algn="ctr">
              <a:defRPr sz="916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26481" y="5861650"/>
            <a:ext cx="13958888" cy="2694446"/>
          </a:xfrm>
        </p:spPr>
        <p:txBody>
          <a:bodyPr/>
          <a:lstStyle>
            <a:lvl1pPr marL="0" indent="0" algn="ctr">
              <a:buNone/>
              <a:defRPr sz="3664"/>
            </a:lvl1pPr>
            <a:lvl2pPr marL="697962" indent="0" algn="ctr">
              <a:buNone/>
              <a:defRPr sz="3053"/>
            </a:lvl2pPr>
            <a:lvl3pPr marL="1395923" indent="0" algn="ctr">
              <a:buNone/>
              <a:defRPr sz="2748"/>
            </a:lvl3pPr>
            <a:lvl4pPr marL="2093885" indent="0" algn="ctr">
              <a:buNone/>
              <a:defRPr sz="2443"/>
            </a:lvl4pPr>
            <a:lvl5pPr marL="2791846" indent="0" algn="ctr">
              <a:buNone/>
              <a:defRPr sz="2443"/>
            </a:lvl5pPr>
            <a:lvl6pPr marL="3489808" indent="0" algn="ctr">
              <a:buNone/>
              <a:defRPr sz="2443"/>
            </a:lvl6pPr>
            <a:lvl7pPr marL="4187769" indent="0" algn="ctr">
              <a:buNone/>
              <a:defRPr sz="2443"/>
            </a:lvl7pPr>
            <a:lvl8pPr marL="4885731" indent="0" algn="ctr">
              <a:buNone/>
              <a:defRPr sz="2443"/>
            </a:lvl8pPr>
            <a:lvl9pPr marL="5583692" indent="0" algn="ctr">
              <a:buNone/>
              <a:defRPr sz="2443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47172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94748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319105" y="594173"/>
            <a:ext cx="4013180" cy="9457690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79565" y="594173"/>
            <a:ext cx="11806892" cy="9457690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46625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65019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69871" y="2782283"/>
            <a:ext cx="16052721" cy="4642301"/>
          </a:xfrm>
        </p:spPr>
        <p:txBody>
          <a:bodyPr anchor="b"/>
          <a:lstStyle>
            <a:lvl1pPr>
              <a:defRPr sz="916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69871" y="7468502"/>
            <a:ext cx="16052721" cy="2441277"/>
          </a:xfrm>
        </p:spPr>
        <p:txBody>
          <a:bodyPr/>
          <a:lstStyle>
            <a:lvl1pPr marL="0" indent="0">
              <a:buNone/>
              <a:defRPr sz="3664">
                <a:solidFill>
                  <a:schemeClr val="tx1">
                    <a:tint val="75000"/>
                  </a:schemeClr>
                </a:solidFill>
              </a:defRPr>
            </a:lvl1pPr>
            <a:lvl2pPr marL="697962" indent="0">
              <a:buNone/>
              <a:defRPr sz="3053">
                <a:solidFill>
                  <a:schemeClr val="tx1">
                    <a:tint val="75000"/>
                  </a:schemeClr>
                </a:solidFill>
              </a:defRPr>
            </a:lvl2pPr>
            <a:lvl3pPr marL="1395923" indent="0">
              <a:buNone/>
              <a:defRPr sz="2748">
                <a:solidFill>
                  <a:schemeClr val="tx1">
                    <a:tint val="75000"/>
                  </a:schemeClr>
                </a:solidFill>
              </a:defRPr>
            </a:lvl3pPr>
            <a:lvl4pPr marL="2093885" indent="0">
              <a:buNone/>
              <a:defRPr sz="2443">
                <a:solidFill>
                  <a:schemeClr val="tx1">
                    <a:tint val="75000"/>
                  </a:schemeClr>
                </a:solidFill>
              </a:defRPr>
            </a:lvl4pPr>
            <a:lvl5pPr marL="2791846" indent="0">
              <a:buNone/>
              <a:defRPr sz="2443">
                <a:solidFill>
                  <a:schemeClr val="tx1">
                    <a:tint val="75000"/>
                  </a:schemeClr>
                </a:solidFill>
              </a:defRPr>
            </a:lvl5pPr>
            <a:lvl6pPr marL="3489808" indent="0">
              <a:buNone/>
              <a:defRPr sz="2443">
                <a:solidFill>
                  <a:schemeClr val="tx1">
                    <a:tint val="75000"/>
                  </a:schemeClr>
                </a:solidFill>
              </a:defRPr>
            </a:lvl6pPr>
            <a:lvl7pPr marL="4187769" indent="0">
              <a:buNone/>
              <a:defRPr sz="2443">
                <a:solidFill>
                  <a:schemeClr val="tx1">
                    <a:tint val="75000"/>
                  </a:schemeClr>
                </a:solidFill>
              </a:defRPr>
            </a:lvl7pPr>
            <a:lvl8pPr marL="4885731" indent="0">
              <a:buNone/>
              <a:defRPr sz="2443">
                <a:solidFill>
                  <a:schemeClr val="tx1">
                    <a:tint val="75000"/>
                  </a:schemeClr>
                </a:solidFill>
              </a:defRPr>
            </a:lvl8pPr>
            <a:lvl9pPr marL="5583692" indent="0">
              <a:buNone/>
              <a:defRPr sz="24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88325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79565" y="2970867"/>
            <a:ext cx="7910036" cy="7080997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22249" y="2970867"/>
            <a:ext cx="7910036" cy="7080997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20429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1989" y="594174"/>
            <a:ext cx="16052721" cy="2157108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81990" y="2735782"/>
            <a:ext cx="7873684" cy="1340764"/>
          </a:xfrm>
        </p:spPr>
        <p:txBody>
          <a:bodyPr anchor="b"/>
          <a:lstStyle>
            <a:lvl1pPr marL="0" indent="0">
              <a:buNone/>
              <a:defRPr sz="3664" b="1"/>
            </a:lvl1pPr>
            <a:lvl2pPr marL="697962" indent="0">
              <a:buNone/>
              <a:defRPr sz="3053" b="1"/>
            </a:lvl2pPr>
            <a:lvl3pPr marL="1395923" indent="0">
              <a:buNone/>
              <a:defRPr sz="2748" b="1"/>
            </a:lvl3pPr>
            <a:lvl4pPr marL="2093885" indent="0">
              <a:buNone/>
              <a:defRPr sz="2443" b="1"/>
            </a:lvl4pPr>
            <a:lvl5pPr marL="2791846" indent="0">
              <a:buNone/>
              <a:defRPr sz="2443" b="1"/>
            </a:lvl5pPr>
            <a:lvl6pPr marL="3489808" indent="0">
              <a:buNone/>
              <a:defRPr sz="2443" b="1"/>
            </a:lvl6pPr>
            <a:lvl7pPr marL="4187769" indent="0">
              <a:buNone/>
              <a:defRPr sz="2443" b="1"/>
            </a:lvl7pPr>
            <a:lvl8pPr marL="4885731" indent="0">
              <a:buNone/>
              <a:defRPr sz="2443" b="1"/>
            </a:lvl8pPr>
            <a:lvl9pPr marL="5583692" indent="0">
              <a:buNone/>
              <a:defRPr sz="2443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81990" y="4076545"/>
            <a:ext cx="7873684" cy="5995985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422249" y="2735782"/>
            <a:ext cx="7912460" cy="1340764"/>
          </a:xfrm>
        </p:spPr>
        <p:txBody>
          <a:bodyPr anchor="b"/>
          <a:lstStyle>
            <a:lvl1pPr marL="0" indent="0">
              <a:buNone/>
              <a:defRPr sz="3664" b="1"/>
            </a:lvl1pPr>
            <a:lvl2pPr marL="697962" indent="0">
              <a:buNone/>
              <a:defRPr sz="3053" b="1"/>
            </a:lvl2pPr>
            <a:lvl3pPr marL="1395923" indent="0">
              <a:buNone/>
              <a:defRPr sz="2748" b="1"/>
            </a:lvl3pPr>
            <a:lvl4pPr marL="2093885" indent="0">
              <a:buNone/>
              <a:defRPr sz="2443" b="1"/>
            </a:lvl4pPr>
            <a:lvl5pPr marL="2791846" indent="0">
              <a:buNone/>
              <a:defRPr sz="2443" b="1"/>
            </a:lvl5pPr>
            <a:lvl6pPr marL="3489808" indent="0">
              <a:buNone/>
              <a:defRPr sz="2443" b="1"/>
            </a:lvl6pPr>
            <a:lvl7pPr marL="4187769" indent="0">
              <a:buNone/>
              <a:defRPr sz="2443" b="1"/>
            </a:lvl7pPr>
            <a:lvl8pPr marL="4885731" indent="0">
              <a:buNone/>
              <a:defRPr sz="2443" b="1"/>
            </a:lvl8pPr>
            <a:lvl9pPr marL="5583692" indent="0">
              <a:buNone/>
              <a:defRPr sz="2443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422249" y="4076545"/>
            <a:ext cx="7912460" cy="5995985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33877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19043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5044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1989" y="744008"/>
            <a:ext cx="6002806" cy="2604029"/>
          </a:xfrm>
        </p:spPr>
        <p:txBody>
          <a:bodyPr anchor="b"/>
          <a:lstStyle>
            <a:lvl1pPr>
              <a:defRPr sz="4885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912460" y="1606852"/>
            <a:ext cx="9422249" cy="7930922"/>
          </a:xfrm>
        </p:spPr>
        <p:txBody>
          <a:bodyPr/>
          <a:lstStyle>
            <a:lvl1pPr>
              <a:defRPr sz="4885"/>
            </a:lvl1pPr>
            <a:lvl2pPr>
              <a:defRPr sz="4274"/>
            </a:lvl2pPr>
            <a:lvl3pPr>
              <a:defRPr sz="3664"/>
            </a:lvl3pPr>
            <a:lvl4pPr>
              <a:defRPr sz="3053"/>
            </a:lvl4pPr>
            <a:lvl5pPr>
              <a:defRPr sz="3053"/>
            </a:lvl5pPr>
            <a:lvl6pPr>
              <a:defRPr sz="3053"/>
            </a:lvl6pPr>
            <a:lvl7pPr>
              <a:defRPr sz="3053"/>
            </a:lvl7pPr>
            <a:lvl8pPr>
              <a:defRPr sz="3053"/>
            </a:lvl8pPr>
            <a:lvl9pPr>
              <a:defRPr sz="3053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1989" y="3348037"/>
            <a:ext cx="6002806" cy="6202654"/>
          </a:xfrm>
        </p:spPr>
        <p:txBody>
          <a:bodyPr/>
          <a:lstStyle>
            <a:lvl1pPr marL="0" indent="0">
              <a:buNone/>
              <a:defRPr sz="2443"/>
            </a:lvl1pPr>
            <a:lvl2pPr marL="697962" indent="0">
              <a:buNone/>
              <a:defRPr sz="2137"/>
            </a:lvl2pPr>
            <a:lvl3pPr marL="1395923" indent="0">
              <a:buNone/>
              <a:defRPr sz="1832"/>
            </a:lvl3pPr>
            <a:lvl4pPr marL="2093885" indent="0">
              <a:buNone/>
              <a:defRPr sz="1527"/>
            </a:lvl4pPr>
            <a:lvl5pPr marL="2791846" indent="0">
              <a:buNone/>
              <a:defRPr sz="1527"/>
            </a:lvl5pPr>
            <a:lvl6pPr marL="3489808" indent="0">
              <a:buNone/>
              <a:defRPr sz="1527"/>
            </a:lvl6pPr>
            <a:lvl7pPr marL="4187769" indent="0">
              <a:buNone/>
              <a:defRPr sz="1527"/>
            </a:lvl7pPr>
            <a:lvl8pPr marL="4885731" indent="0">
              <a:buNone/>
              <a:defRPr sz="1527"/>
            </a:lvl8pPr>
            <a:lvl9pPr marL="5583692" indent="0">
              <a:buNone/>
              <a:defRPr sz="1527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3467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1989" y="744008"/>
            <a:ext cx="6002806" cy="2604029"/>
          </a:xfrm>
        </p:spPr>
        <p:txBody>
          <a:bodyPr anchor="b"/>
          <a:lstStyle>
            <a:lvl1pPr>
              <a:defRPr sz="4885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912460" y="1606852"/>
            <a:ext cx="9422249" cy="7930922"/>
          </a:xfrm>
        </p:spPr>
        <p:txBody>
          <a:bodyPr anchor="t"/>
          <a:lstStyle>
            <a:lvl1pPr marL="0" indent="0">
              <a:buNone/>
              <a:defRPr sz="4885"/>
            </a:lvl1pPr>
            <a:lvl2pPr marL="697962" indent="0">
              <a:buNone/>
              <a:defRPr sz="4274"/>
            </a:lvl2pPr>
            <a:lvl3pPr marL="1395923" indent="0">
              <a:buNone/>
              <a:defRPr sz="3664"/>
            </a:lvl3pPr>
            <a:lvl4pPr marL="2093885" indent="0">
              <a:buNone/>
              <a:defRPr sz="3053"/>
            </a:lvl4pPr>
            <a:lvl5pPr marL="2791846" indent="0">
              <a:buNone/>
              <a:defRPr sz="3053"/>
            </a:lvl5pPr>
            <a:lvl6pPr marL="3489808" indent="0">
              <a:buNone/>
              <a:defRPr sz="3053"/>
            </a:lvl6pPr>
            <a:lvl7pPr marL="4187769" indent="0">
              <a:buNone/>
              <a:defRPr sz="3053"/>
            </a:lvl7pPr>
            <a:lvl8pPr marL="4885731" indent="0">
              <a:buNone/>
              <a:defRPr sz="3053"/>
            </a:lvl8pPr>
            <a:lvl9pPr marL="5583692" indent="0">
              <a:buNone/>
              <a:defRPr sz="3053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1989" y="3348037"/>
            <a:ext cx="6002806" cy="6202654"/>
          </a:xfrm>
        </p:spPr>
        <p:txBody>
          <a:bodyPr/>
          <a:lstStyle>
            <a:lvl1pPr marL="0" indent="0">
              <a:buNone/>
              <a:defRPr sz="2443"/>
            </a:lvl1pPr>
            <a:lvl2pPr marL="697962" indent="0">
              <a:buNone/>
              <a:defRPr sz="2137"/>
            </a:lvl2pPr>
            <a:lvl3pPr marL="1395923" indent="0">
              <a:buNone/>
              <a:defRPr sz="1832"/>
            </a:lvl3pPr>
            <a:lvl4pPr marL="2093885" indent="0">
              <a:buNone/>
              <a:defRPr sz="1527"/>
            </a:lvl4pPr>
            <a:lvl5pPr marL="2791846" indent="0">
              <a:buNone/>
              <a:defRPr sz="1527"/>
            </a:lvl5pPr>
            <a:lvl6pPr marL="3489808" indent="0">
              <a:buNone/>
              <a:defRPr sz="1527"/>
            </a:lvl6pPr>
            <a:lvl7pPr marL="4187769" indent="0">
              <a:buNone/>
              <a:defRPr sz="1527"/>
            </a:lvl7pPr>
            <a:lvl8pPr marL="4885731" indent="0">
              <a:buNone/>
              <a:defRPr sz="1527"/>
            </a:lvl8pPr>
            <a:lvl9pPr marL="5583692" indent="0">
              <a:buNone/>
              <a:defRPr sz="1527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68324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79565" y="594174"/>
            <a:ext cx="16052721" cy="2157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79565" y="2970867"/>
            <a:ext cx="16052721" cy="70809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79565" y="10343783"/>
            <a:ext cx="4187666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7782C5-F0EC-7348-B9A5-0A757D1D7265}" type="datetimeFigureOut">
              <a:rPr lang="el-GR" smtClean="0"/>
              <a:t>5/8/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165176" y="10343783"/>
            <a:ext cx="6281499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44619" y="10343783"/>
            <a:ext cx="4187666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4616F-E44B-3E40-B5CE-9FAC705FD8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26214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1395923" rtl="0" eaLnBrk="1" latinLnBrk="0" hangingPunct="1">
        <a:lnSpc>
          <a:spcPct val="90000"/>
        </a:lnSpc>
        <a:spcBef>
          <a:spcPct val="0"/>
        </a:spcBef>
        <a:buNone/>
        <a:defRPr sz="671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8981" indent="-348981" algn="l" defTabSz="1395923" rtl="0" eaLnBrk="1" latinLnBrk="0" hangingPunct="1">
        <a:lnSpc>
          <a:spcPct val="90000"/>
        </a:lnSpc>
        <a:spcBef>
          <a:spcPts val="1527"/>
        </a:spcBef>
        <a:buFont typeface="Arial" panose="020B0604020202020204" pitchFamily="34" charset="0"/>
        <a:buChar char="•"/>
        <a:defRPr sz="4274" kern="1200">
          <a:solidFill>
            <a:schemeClr val="tx1"/>
          </a:solidFill>
          <a:latin typeface="+mn-lt"/>
          <a:ea typeface="+mn-ea"/>
          <a:cs typeface="+mn-cs"/>
        </a:defRPr>
      </a:lvl1pPr>
      <a:lvl2pPr marL="1046942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3664" kern="1200">
          <a:solidFill>
            <a:schemeClr val="tx1"/>
          </a:solidFill>
          <a:latin typeface="+mn-lt"/>
          <a:ea typeface="+mn-ea"/>
          <a:cs typeface="+mn-cs"/>
        </a:defRPr>
      </a:lvl2pPr>
      <a:lvl3pPr marL="1744904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3053" kern="1200">
          <a:solidFill>
            <a:schemeClr val="tx1"/>
          </a:solidFill>
          <a:latin typeface="+mn-lt"/>
          <a:ea typeface="+mn-ea"/>
          <a:cs typeface="+mn-cs"/>
        </a:defRPr>
      </a:lvl3pPr>
      <a:lvl4pPr marL="2442865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8" kern="1200">
          <a:solidFill>
            <a:schemeClr val="tx1"/>
          </a:solidFill>
          <a:latin typeface="+mn-lt"/>
          <a:ea typeface="+mn-ea"/>
          <a:cs typeface="+mn-cs"/>
        </a:defRPr>
      </a:lvl4pPr>
      <a:lvl5pPr marL="3140827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8" kern="1200">
          <a:solidFill>
            <a:schemeClr val="tx1"/>
          </a:solidFill>
          <a:latin typeface="+mn-lt"/>
          <a:ea typeface="+mn-ea"/>
          <a:cs typeface="+mn-cs"/>
        </a:defRPr>
      </a:lvl5pPr>
      <a:lvl6pPr marL="3838788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8" kern="1200">
          <a:solidFill>
            <a:schemeClr val="tx1"/>
          </a:solidFill>
          <a:latin typeface="+mn-lt"/>
          <a:ea typeface="+mn-ea"/>
          <a:cs typeface="+mn-cs"/>
        </a:defRPr>
      </a:lvl6pPr>
      <a:lvl7pPr marL="4536750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8" kern="1200">
          <a:solidFill>
            <a:schemeClr val="tx1"/>
          </a:solidFill>
          <a:latin typeface="+mn-lt"/>
          <a:ea typeface="+mn-ea"/>
          <a:cs typeface="+mn-cs"/>
        </a:defRPr>
      </a:lvl7pPr>
      <a:lvl8pPr marL="5234711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8" kern="1200">
          <a:solidFill>
            <a:schemeClr val="tx1"/>
          </a:solidFill>
          <a:latin typeface="+mn-lt"/>
          <a:ea typeface="+mn-ea"/>
          <a:cs typeface="+mn-cs"/>
        </a:defRPr>
      </a:lvl8pPr>
      <a:lvl9pPr marL="5932673" indent="-348981" algn="l" defTabSz="1395923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1pPr>
      <a:lvl2pPr marL="697962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2pPr>
      <a:lvl3pPr marL="1395923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3pPr>
      <a:lvl4pPr marL="2093885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4pPr>
      <a:lvl5pPr marL="2791846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5pPr>
      <a:lvl6pPr marL="3489808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6pPr>
      <a:lvl7pPr marL="4187769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7pPr>
      <a:lvl8pPr marL="4885731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8pPr>
      <a:lvl9pPr marL="5583692" algn="l" defTabSz="1395923" rtl="0" eaLnBrk="1" latinLnBrk="0" hangingPunct="1">
        <a:defRPr sz="274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1" name="Ομάδα 200">
            <a:extLst>
              <a:ext uri="{FF2B5EF4-FFF2-40B4-BE49-F238E27FC236}">
                <a16:creationId xmlns:a16="http://schemas.microsoft.com/office/drawing/2014/main" id="{2F37DF06-B74A-4F49-B3E7-C6CC1A5E9AE9}"/>
              </a:ext>
            </a:extLst>
          </p:cNvPr>
          <p:cNvGrpSpPr/>
          <p:nvPr/>
        </p:nvGrpSpPr>
        <p:grpSpPr>
          <a:xfrm>
            <a:off x="63419" y="-15689"/>
            <a:ext cx="18546057" cy="11174029"/>
            <a:chOff x="63419" y="44271"/>
            <a:chExt cx="18546057" cy="11174029"/>
          </a:xfrm>
        </p:grpSpPr>
        <p:pic>
          <p:nvPicPr>
            <p:cNvPr id="202" name="Εικόνα 201">
              <a:extLst>
                <a:ext uri="{FF2B5EF4-FFF2-40B4-BE49-F238E27FC236}">
                  <a16:creationId xmlns:a16="http://schemas.microsoft.com/office/drawing/2014/main" id="{A790F6A6-2F83-4843-8291-685986D90B9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07640" y="5473215"/>
              <a:ext cx="4515897" cy="2664000"/>
            </a:xfrm>
            <a:prstGeom prst="rect">
              <a:avLst/>
            </a:prstGeom>
          </p:spPr>
        </p:pic>
        <p:pic>
          <p:nvPicPr>
            <p:cNvPr id="203" name="Εικόνα 202">
              <a:extLst>
                <a:ext uri="{FF2B5EF4-FFF2-40B4-BE49-F238E27FC236}">
                  <a16:creationId xmlns:a16="http://schemas.microsoft.com/office/drawing/2014/main" id="{967EA617-0AB6-0246-9E7A-15320F88066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412797" y="2775874"/>
              <a:ext cx="4438125" cy="2664000"/>
            </a:xfrm>
            <a:prstGeom prst="rect">
              <a:avLst/>
            </a:prstGeom>
          </p:spPr>
        </p:pic>
        <p:pic>
          <p:nvPicPr>
            <p:cNvPr id="204" name="Εικόνα 203">
              <a:extLst>
                <a:ext uri="{FF2B5EF4-FFF2-40B4-BE49-F238E27FC236}">
                  <a16:creationId xmlns:a16="http://schemas.microsoft.com/office/drawing/2014/main" id="{FC1769FC-736A-7541-A670-6CD326B5403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5463" y="8283785"/>
              <a:ext cx="4533899" cy="2664000"/>
            </a:xfrm>
            <a:prstGeom prst="rect">
              <a:avLst/>
            </a:prstGeom>
          </p:spPr>
        </p:pic>
        <p:pic>
          <p:nvPicPr>
            <p:cNvPr id="205" name="Εικόνα 204">
              <a:extLst>
                <a:ext uri="{FF2B5EF4-FFF2-40B4-BE49-F238E27FC236}">
                  <a16:creationId xmlns:a16="http://schemas.microsoft.com/office/drawing/2014/main" id="{103016A4-B077-7949-B912-E7BC41AEC90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761007" y="2776076"/>
              <a:ext cx="4489992" cy="2664000"/>
            </a:xfrm>
            <a:prstGeom prst="rect">
              <a:avLst/>
            </a:prstGeom>
          </p:spPr>
        </p:pic>
        <p:pic>
          <p:nvPicPr>
            <p:cNvPr id="206" name="Εικόνα 205">
              <a:extLst>
                <a:ext uri="{FF2B5EF4-FFF2-40B4-BE49-F238E27FC236}">
                  <a16:creationId xmlns:a16="http://schemas.microsoft.com/office/drawing/2014/main" id="{17199DBF-7645-674B-8CDE-75E5EAF3636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4985" y="2776076"/>
              <a:ext cx="4438125" cy="2664000"/>
            </a:xfrm>
            <a:prstGeom prst="rect">
              <a:avLst/>
            </a:prstGeom>
          </p:spPr>
        </p:pic>
        <p:pic>
          <p:nvPicPr>
            <p:cNvPr id="207" name="Εικόνα 206">
              <a:extLst>
                <a:ext uri="{FF2B5EF4-FFF2-40B4-BE49-F238E27FC236}">
                  <a16:creationId xmlns:a16="http://schemas.microsoft.com/office/drawing/2014/main" id="{293DBE7C-9AB7-B24F-ABAD-22478A881FA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402417" y="78937"/>
              <a:ext cx="4438125" cy="2664000"/>
            </a:xfrm>
            <a:prstGeom prst="rect">
              <a:avLst/>
            </a:prstGeom>
          </p:spPr>
        </p:pic>
        <p:pic>
          <p:nvPicPr>
            <p:cNvPr id="208" name="Εικόνα 207">
              <a:extLst>
                <a:ext uri="{FF2B5EF4-FFF2-40B4-BE49-F238E27FC236}">
                  <a16:creationId xmlns:a16="http://schemas.microsoft.com/office/drawing/2014/main" id="{0820C064-E7B1-DC4D-8469-EBF1D5ABB97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44836" y="5462176"/>
              <a:ext cx="4518274" cy="2664000"/>
            </a:xfrm>
            <a:prstGeom prst="rect">
              <a:avLst/>
            </a:prstGeom>
          </p:spPr>
        </p:pic>
        <p:pic>
          <p:nvPicPr>
            <p:cNvPr id="209" name="Εικόνα 208">
              <a:extLst>
                <a:ext uri="{FF2B5EF4-FFF2-40B4-BE49-F238E27FC236}">
                  <a16:creationId xmlns:a16="http://schemas.microsoft.com/office/drawing/2014/main" id="{3D8D35DB-526F-F84A-828B-37836CEC2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814966" y="78938"/>
              <a:ext cx="4438125" cy="2664000"/>
            </a:xfrm>
            <a:prstGeom prst="rect">
              <a:avLst/>
            </a:prstGeom>
          </p:spPr>
        </p:pic>
        <p:pic>
          <p:nvPicPr>
            <p:cNvPr id="210" name="Εικόνα 209">
              <a:extLst>
                <a:ext uri="{FF2B5EF4-FFF2-40B4-BE49-F238E27FC236}">
                  <a16:creationId xmlns:a16="http://schemas.microsoft.com/office/drawing/2014/main" id="{7BD029C9-803D-704D-86B8-9D7EA54634C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985412" y="2787227"/>
              <a:ext cx="4438125" cy="2664000"/>
            </a:xfrm>
            <a:prstGeom prst="rect">
              <a:avLst/>
            </a:prstGeom>
          </p:spPr>
        </p:pic>
        <p:pic>
          <p:nvPicPr>
            <p:cNvPr id="211" name="Εικόνα 210">
              <a:extLst>
                <a:ext uri="{FF2B5EF4-FFF2-40B4-BE49-F238E27FC236}">
                  <a16:creationId xmlns:a16="http://schemas.microsoft.com/office/drawing/2014/main" id="{FACFB808-DD81-BA48-A07A-9B98D7B4F3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929657" y="44271"/>
              <a:ext cx="4483911" cy="2664000"/>
            </a:xfrm>
            <a:prstGeom prst="rect">
              <a:avLst/>
            </a:prstGeom>
          </p:spPr>
        </p:pic>
        <p:pic>
          <p:nvPicPr>
            <p:cNvPr id="212" name="Εικόνα 211">
              <a:extLst>
                <a:ext uri="{FF2B5EF4-FFF2-40B4-BE49-F238E27FC236}">
                  <a16:creationId xmlns:a16="http://schemas.microsoft.com/office/drawing/2014/main" id="{08A6E04A-16B6-7044-AD4E-48DB3755B6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975443" y="8269518"/>
              <a:ext cx="4438125" cy="2664000"/>
            </a:xfrm>
            <a:prstGeom prst="rect">
              <a:avLst/>
            </a:prstGeom>
          </p:spPr>
        </p:pic>
        <p:pic>
          <p:nvPicPr>
            <p:cNvPr id="213" name="Εικόνα 212">
              <a:extLst>
                <a:ext uri="{FF2B5EF4-FFF2-40B4-BE49-F238E27FC236}">
                  <a16:creationId xmlns:a16="http://schemas.microsoft.com/office/drawing/2014/main" id="{D9E488A9-9B0B-2043-A96D-3D20C74D325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540852" y="6221975"/>
              <a:ext cx="7200000" cy="4321825"/>
            </a:xfrm>
            <a:prstGeom prst="rect">
              <a:avLst/>
            </a:prstGeom>
          </p:spPr>
        </p:pic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B537AC00-15D1-7447-AB6F-F73013E65259}"/>
                </a:ext>
              </a:extLst>
            </p:cNvPr>
            <p:cNvSpPr txBox="1"/>
            <p:nvPr/>
          </p:nvSpPr>
          <p:spPr>
            <a:xfrm>
              <a:off x="8091327" y="261314"/>
              <a:ext cx="1159292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aPEL.7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664EA39A-B407-8F42-B06E-B35AEB3C3F6D}"/>
                </a:ext>
              </a:extLst>
            </p:cNvPr>
            <p:cNvSpPr txBox="1"/>
            <p:nvPr/>
          </p:nvSpPr>
          <p:spPr>
            <a:xfrm>
              <a:off x="855265" y="5673589"/>
              <a:ext cx="1235788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aPAE.1 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2E82E9F5-8236-E540-A3E7-6677CAF5D110}"/>
                </a:ext>
              </a:extLst>
            </p:cNvPr>
            <p:cNvSpPr txBox="1"/>
            <p:nvPr/>
          </p:nvSpPr>
          <p:spPr>
            <a:xfrm>
              <a:off x="884045" y="2955907"/>
              <a:ext cx="1228221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aSAM5 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F4785145-F979-C349-9921-82615A1A5BE2}"/>
                </a:ext>
              </a:extLst>
            </p:cNvPr>
            <p:cNvSpPr txBox="1"/>
            <p:nvPr/>
          </p:nvSpPr>
          <p:spPr>
            <a:xfrm>
              <a:off x="14189152" y="2955072"/>
              <a:ext cx="862737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aA4 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7C7441C7-9297-1447-97A7-0608E7386FB9}"/>
                </a:ext>
              </a:extLst>
            </p:cNvPr>
            <p:cNvSpPr txBox="1"/>
            <p:nvPr/>
          </p:nvSpPr>
          <p:spPr>
            <a:xfrm>
              <a:off x="841071" y="10376719"/>
              <a:ext cx="1339406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PIP</a:t>
              </a:r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2.4 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5A831710-E65A-754A-BE86-7D094A3B5D9E}"/>
                </a:ext>
              </a:extLst>
            </p:cNvPr>
            <p:cNvSpPr txBox="1"/>
            <p:nvPr/>
          </p:nvSpPr>
          <p:spPr>
            <a:xfrm>
              <a:off x="9758070" y="2991492"/>
              <a:ext cx="1339406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SIP</a:t>
              </a:r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2.1 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09CC0A7E-9C08-564A-A4DB-4D22D552519E}"/>
                </a:ext>
              </a:extLst>
            </p:cNvPr>
            <p:cNvSpPr txBox="1"/>
            <p:nvPr/>
          </p:nvSpPr>
          <p:spPr>
            <a:xfrm>
              <a:off x="12950735" y="10543800"/>
              <a:ext cx="25891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NA-seq (Log</a:t>
              </a:r>
              <a:r>
                <a:rPr lang="en-US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(FC))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8B90EDF7-E9D1-7545-BBCE-F97CDF5FF7D9}"/>
                </a:ext>
              </a:extLst>
            </p:cNvPr>
            <p:cNvSpPr txBox="1"/>
            <p:nvPr/>
          </p:nvSpPr>
          <p:spPr>
            <a:xfrm>
              <a:off x="8146946" y="5665268"/>
              <a:ext cx="1132041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PLSC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E16DD449-334C-3843-8531-30E006ACFBC7}"/>
                </a:ext>
              </a:extLst>
            </p:cNvPr>
            <p:cNvSpPr txBox="1"/>
            <p:nvPr/>
          </p:nvSpPr>
          <p:spPr>
            <a:xfrm>
              <a:off x="8370120" y="3017021"/>
              <a:ext cx="888385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INV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D2ADF6BD-7991-A447-A4FF-1AB937574261}"/>
                </a:ext>
              </a:extLst>
            </p:cNvPr>
            <p:cNvSpPr txBox="1"/>
            <p:nvPr/>
          </p:nvSpPr>
          <p:spPr>
            <a:xfrm>
              <a:off x="14173242" y="276812"/>
              <a:ext cx="833883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GP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FF971E0E-80CD-964D-BD19-29EF87AB4D09}"/>
                </a:ext>
              </a:extLst>
            </p:cNvPr>
            <p:cNvSpPr txBox="1"/>
            <p:nvPr/>
          </p:nvSpPr>
          <p:spPr>
            <a:xfrm rot="16200000">
              <a:off x="9203306" y="8112492"/>
              <a:ext cx="22640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T-qPCR (-</a:t>
              </a:r>
              <a:r>
                <a:rPr lang="el-G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ΔΔ</a:t>
              </a:r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t)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0F0C81AD-7C62-3545-8E21-DE3343F0AEF7}"/>
                </a:ext>
              </a:extLst>
            </p:cNvPr>
            <p:cNvSpPr txBox="1"/>
            <p:nvPr/>
          </p:nvSpPr>
          <p:spPr>
            <a:xfrm>
              <a:off x="8192266" y="8478761"/>
              <a:ext cx="1079142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ADH</a:t>
              </a:r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7634E760-DCD0-4E40-A5EE-4A6EB3AEF3D4}"/>
                </a:ext>
              </a:extLst>
            </p:cNvPr>
            <p:cNvSpPr txBox="1"/>
            <p:nvPr/>
          </p:nvSpPr>
          <p:spPr>
            <a:xfrm rot="16200000">
              <a:off x="-1032714" y="9401463"/>
              <a:ext cx="25923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F89B4A7B-04B7-4849-ABBB-094EADA3FC79}"/>
                </a:ext>
              </a:extLst>
            </p:cNvPr>
            <p:cNvSpPr txBox="1"/>
            <p:nvPr/>
          </p:nvSpPr>
          <p:spPr>
            <a:xfrm rot="16200000">
              <a:off x="-1017216" y="6569587"/>
              <a:ext cx="25923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7CB75ACD-C691-C349-A9D1-29A1C1042E8F}"/>
                </a:ext>
              </a:extLst>
            </p:cNvPr>
            <p:cNvSpPr txBox="1"/>
            <p:nvPr/>
          </p:nvSpPr>
          <p:spPr>
            <a:xfrm rot="16200000">
              <a:off x="-1004511" y="3828545"/>
              <a:ext cx="25923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0738A5C8-F033-5841-B8A7-64770EF0A001}"/>
                </a:ext>
              </a:extLst>
            </p:cNvPr>
            <p:cNvSpPr txBox="1"/>
            <p:nvPr/>
          </p:nvSpPr>
          <p:spPr>
            <a:xfrm rot="16200000">
              <a:off x="3470530" y="1173831"/>
              <a:ext cx="25923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8CDDE993-02AA-2D4F-80B5-2FB08E558213}"/>
                </a:ext>
              </a:extLst>
            </p:cNvPr>
            <p:cNvSpPr txBox="1"/>
            <p:nvPr/>
          </p:nvSpPr>
          <p:spPr>
            <a:xfrm>
              <a:off x="897456" y="10813246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3E836118-688C-4C41-A7CC-5F4060EB4B29}"/>
                </a:ext>
              </a:extLst>
            </p:cNvPr>
            <p:cNvSpPr txBox="1"/>
            <p:nvPr/>
          </p:nvSpPr>
          <p:spPr>
            <a:xfrm>
              <a:off x="1858644" y="10818190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C1C46337-A14D-3845-A5C9-CD9D040ECEED}"/>
                </a:ext>
              </a:extLst>
            </p:cNvPr>
            <p:cNvSpPr txBox="1"/>
            <p:nvPr/>
          </p:nvSpPr>
          <p:spPr>
            <a:xfrm>
              <a:off x="2917115" y="10813246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A2A95B61-B9B7-8B41-AE4E-9E16FF22ED94}"/>
                </a:ext>
              </a:extLst>
            </p:cNvPr>
            <p:cNvSpPr txBox="1"/>
            <p:nvPr/>
          </p:nvSpPr>
          <p:spPr>
            <a:xfrm>
              <a:off x="3878303" y="10818190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6A34FBD4-ABC8-204F-91C7-27704383EB07}"/>
                </a:ext>
              </a:extLst>
            </p:cNvPr>
            <p:cNvSpPr txBox="1"/>
            <p:nvPr/>
          </p:nvSpPr>
          <p:spPr>
            <a:xfrm>
              <a:off x="5374020" y="10813246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8951E31B-7F53-924E-9197-D09CDB10834F}"/>
                </a:ext>
              </a:extLst>
            </p:cNvPr>
            <p:cNvSpPr txBox="1"/>
            <p:nvPr/>
          </p:nvSpPr>
          <p:spPr>
            <a:xfrm>
              <a:off x="6335208" y="10818190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A13AD76C-8F80-D849-B2BE-12986FEAFCC6}"/>
                </a:ext>
              </a:extLst>
            </p:cNvPr>
            <p:cNvSpPr txBox="1"/>
            <p:nvPr/>
          </p:nvSpPr>
          <p:spPr>
            <a:xfrm>
              <a:off x="7393679" y="10813246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7E478973-C401-BC41-94A0-CC60D7D2BAE8}"/>
                </a:ext>
              </a:extLst>
            </p:cNvPr>
            <p:cNvSpPr txBox="1"/>
            <p:nvPr/>
          </p:nvSpPr>
          <p:spPr>
            <a:xfrm>
              <a:off x="8354867" y="10818190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ABC22124-E974-474A-BE45-6239E7C9D4E6}"/>
                </a:ext>
              </a:extLst>
            </p:cNvPr>
            <p:cNvSpPr txBox="1"/>
            <p:nvPr/>
          </p:nvSpPr>
          <p:spPr>
            <a:xfrm>
              <a:off x="9809665" y="5305977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3F9F8B9E-C6E2-394C-8AF4-30558A8C8923}"/>
                </a:ext>
              </a:extLst>
            </p:cNvPr>
            <p:cNvSpPr txBox="1"/>
            <p:nvPr/>
          </p:nvSpPr>
          <p:spPr>
            <a:xfrm>
              <a:off x="10786093" y="5310921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03598764-EC87-804D-AB1A-C4D53F1A7A89}"/>
                </a:ext>
              </a:extLst>
            </p:cNvPr>
            <p:cNvSpPr txBox="1"/>
            <p:nvPr/>
          </p:nvSpPr>
          <p:spPr>
            <a:xfrm>
              <a:off x="11844564" y="5305977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9031690C-B7CF-F246-B136-7F0A2317909C}"/>
                </a:ext>
              </a:extLst>
            </p:cNvPr>
            <p:cNvSpPr txBox="1"/>
            <p:nvPr/>
          </p:nvSpPr>
          <p:spPr>
            <a:xfrm>
              <a:off x="12805752" y="5310921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B652E717-0230-9242-8E7E-022516181AC0}"/>
                </a:ext>
              </a:extLst>
            </p:cNvPr>
            <p:cNvSpPr txBox="1"/>
            <p:nvPr/>
          </p:nvSpPr>
          <p:spPr>
            <a:xfrm>
              <a:off x="14255749" y="5305977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E1542C47-F847-EE45-A3A2-E77171563134}"/>
                </a:ext>
              </a:extLst>
            </p:cNvPr>
            <p:cNvSpPr txBox="1"/>
            <p:nvPr/>
          </p:nvSpPr>
          <p:spPr>
            <a:xfrm>
              <a:off x="15171217" y="5310921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217F7748-735A-E844-B74A-CBABC0EE8270}"/>
                </a:ext>
              </a:extLst>
            </p:cNvPr>
            <p:cNvSpPr txBox="1"/>
            <p:nvPr/>
          </p:nvSpPr>
          <p:spPr>
            <a:xfrm>
              <a:off x="16321128" y="5305977"/>
              <a:ext cx="7841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45C34A8F-552F-4942-8160-2B1BAC34AB39}"/>
                </a:ext>
              </a:extLst>
            </p:cNvPr>
            <p:cNvSpPr txBox="1"/>
            <p:nvPr/>
          </p:nvSpPr>
          <p:spPr>
            <a:xfrm>
              <a:off x="17236596" y="5310921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D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Ορθογώνιο 245">
              <a:extLst>
                <a:ext uri="{FF2B5EF4-FFF2-40B4-BE49-F238E27FC236}">
                  <a16:creationId xmlns:a16="http://schemas.microsoft.com/office/drawing/2014/main" id="{DD41D75E-FF2E-E74F-8D98-D8A65DCDA6B8}"/>
                </a:ext>
              </a:extLst>
            </p:cNvPr>
            <p:cNvSpPr/>
            <p:nvPr/>
          </p:nvSpPr>
          <p:spPr>
            <a:xfrm>
              <a:off x="844349" y="1396260"/>
              <a:ext cx="575417" cy="36197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1A715DE9-8523-E046-8093-B5C1E4B8ED95}"/>
                </a:ext>
              </a:extLst>
            </p:cNvPr>
            <p:cNvSpPr txBox="1"/>
            <p:nvPr/>
          </p:nvSpPr>
          <p:spPr>
            <a:xfrm>
              <a:off x="1449051" y="1391304"/>
              <a:ext cx="287636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T-qPCR (-</a:t>
              </a:r>
              <a:r>
                <a:rPr lang="el-G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ΔΔ</a:t>
              </a:r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t) Skin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Ορθογώνιο 247">
              <a:extLst>
                <a:ext uri="{FF2B5EF4-FFF2-40B4-BE49-F238E27FC236}">
                  <a16:creationId xmlns:a16="http://schemas.microsoft.com/office/drawing/2014/main" id="{63575F94-6922-FE48-916E-43A9E93DF921}"/>
                </a:ext>
              </a:extLst>
            </p:cNvPr>
            <p:cNvSpPr/>
            <p:nvPr/>
          </p:nvSpPr>
          <p:spPr>
            <a:xfrm>
              <a:off x="837776" y="1963803"/>
              <a:ext cx="575417" cy="361977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75A3869F-130C-C943-91ED-AD5C21A92692}"/>
                </a:ext>
              </a:extLst>
            </p:cNvPr>
            <p:cNvSpPr txBox="1"/>
            <p:nvPr/>
          </p:nvSpPr>
          <p:spPr>
            <a:xfrm>
              <a:off x="1449051" y="1956158"/>
              <a:ext cx="293407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T-qPCR(-</a:t>
              </a:r>
              <a:r>
                <a:rPr lang="el-G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ΔΔ</a:t>
              </a:r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t) Flesh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EA529C41-0D30-0449-A849-7E89651C2BD7}"/>
                </a:ext>
              </a:extLst>
            </p:cNvPr>
            <p:cNvSpPr txBox="1"/>
            <p:nvPr/>
          </p:nvSpPr>
          <p:spPr>
            <a:xfrm>
              <a:off x="9768249" y="294397"/>
              <a:ext cx="1281120" cy="3847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aPMEI.5</a:t>
              </a:r>
              <a:endParaRPr lang="el-GR" sz="1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415C6685-DFEB-0646-922F-D331D0567C43}"/>
                </a:ext>
              </a:extLst>
            </p:cNvPr>
            <p:cNvSpPr txBox="1"/>
            <p:nvPr/>
          </p:nvSpPr>
          <p:spPr>
            <a:xfrm rot="5400000">
              <a:off x="17103854" y="1246694"/>
              <a:ext cx="25923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24553258-4D9E-C547-A7FE-F2C1865EF371}"/>
                </a:ext>
              </a:extLst>
            </p:cNvPr>
            <p:cNvSpPr txBox="1"/>
            <p:nvPr/>
          </p:nvSpPr>
          <p:spPr>
            <a:xfrm rot="5400000">
              <a:off x="17113233" y="3944694"/>
              <a:ext cx="25923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Ευθεία γραμμή σύνδεσης 252">
              <a:extLst>
                <a:ext uri="{FF2B5EF4-FFF2-40B4-BE49-F238E27FC236}">
                  <a16:creationId xmlns:a16="http://schemas.microsoft.com/office/drawing/2014/main" id="{5CA84B1F-909B-E24E-BAC7-23C68054B894}"/>
                </a:ext>
              </a:extLst>
            </p:cNvPr>
            <p:cNvCxnSpPr/>
            <p:nvPr/>
          </p:nvCxnSpPr>
          <p:spPr>
            <a:xfrm>
              <a:off x="862167" y="799894"/>
              <a:ext cx="575417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98EABE81-A7D2-2843-8B7C-F085BC04D4C5}"/>
                </a:ext>
              </a:extLst>
            </p:cNvPr>
            <p:cNvSpPr txBox="1"/>
            <p:nvPr/>
          </p:nvSpPr>
          <p:spPr>
            <a:xfrm>
              <a:off x="1537942" y="612706"/>
              <a:ext cx="25891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RNA-seq (Log</a:t>
              </a:r>
              <a:r>
                <a:rPr lang="en-US" sz="2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(FC))</a:t>
              </a:r>
              <a:endParaRPr lang="el-GR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09694461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6</TotalTime>
  <Words>77</Words>
  <Application>Microsoft Macintosh PowerPoint</Application>
  <PresentationFormat>Προσαρμογή</PresentationFormat>
  <Paragraphs>39</Paragraphs>
  <Slides>1</Slides>
  <Notes>1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Athanasios Molasiotis</dc:creator>
  <cp:lastModifiedBy>Athanasios Molasiotis</cp:lastModifiedBy>
  <cp:revision>42</cp:revision>
  <dcterms:created xsi:type="dcterms:W3CDTF">2020-03-25T13:33:09Z</dcterms:created>
  <dcterms:modified xsi:type="dcterms:W3CDTF">2020-08-05T13:42:04Z</dcterms:modified>
</cp:coreProperties>
</file>